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2"/>
  </p:notesMasterIdLst>
  <p:sldIdLst>
    <p:sldId id="294" r:id="rId2"/>
    <p:sldId id="278" r:id="rId3"/>
    <p:sldId id="281" r:id="rId4"/>
    <p:sldId id="280" r:id="rId5"/>
    <p:sldId id="279" r:id="rId6"/>
    <p:sldId id="299" r:id="rId7"/>
    <p:sldId id="277" r:id="rId8"/>
    <p:sldId id="276" r:id="rId9"/>
    <p:sldId id="285" r:id="rId10"/>
    <p:sldId id="284" r:id="rId11"/>
  </p:sldIdLst>
  <p:sldSz cx="12192000" cy="6858000"/>
  <p:notesSz cx="6858000" cy="9144000"/>
  <p:defaultTextStyle>
    <a:defPPr>
      <a:defRPr lang="en-P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883" autoAdjust="0"/>
    <p:restoredTop sz="74750"/>
  </p:normalViewPr>
  <p:slideViewPr>
    <p:cSldViewPr snapToGrid="0" snapToObjects="1">
      <p:cViewPr varScale="1">
        <p:scale>
          <a:sx n="64" d="100"/>
          <a:sy n="64" d="100"/>
        </p:scale>
        <p:origin x="1382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P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C80C00-1345-C040-8EC5-CB8C1B4B79F9}" type="datetimeFigureOut">
              <a:rPr lang="en-PR" smtClean="0"/>
              <a:t>03/27/2024</a:t>
            </a:fld>
            <a:endParaRPr lang="en-P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P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P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EAE507-DE51-7F49-9CFE-6816C9B4CD5E}" type="slidenum">
              <a:rPr lang="en-PR" smtClean="0"/>
              <a:t>‹#›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9925112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1. </a:t>
            </a:r>
            <a:r>
              <a:rPr lang="en-US" sz="18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RTargetLink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2.0 Gene Interaction pathway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is pathway visualizes predicted strong interactions between 2 or more miRNA for each target gene. miRNA’s are shown in blue, genes with two miRNA interactions are shown in green, while those with 3 interactions are shown in yellow. Genes with 4 interactors are shown in red. hsa-miR-1206 does not appear in the pathway since no strong interaction genes are shared with the other miRNA.</a:t>
            </a:r>
            <a:endParaRPr lang="en-PR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P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E6F0BAF-FBD3-42A6-B8DF-F5EE09EE33D8}" type="slidenum">
              <a:rPr lang="en-PR" smtClean="0"/>
              <a:t>1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734048420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S2I. </a:t>
            </a:r>
            <a:r>
              <a:rPr lang="en-US" b="1" dirty="0" err="1"/>
              <a:t>miRTargetLink</a:t>
            </a:r>
            <a:r>
              <a:rPr lang="en-US" b="1" dirty="0"/>
              <a:t> 2.0 Gene Interaction pathway for miR-1206. </a:t>
            </a:r>
            <a:endParaRPr lang="en-PR" b="1" dirty="0"/>
          </a:p>
          <a:p>
            <a:endParaRPr lang="en-P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EAE507-DE51-7F49-9CFE-6816C9B4CD5E}" type="slidenum">
              <a:rPr lang="en-PR" smtClean="0"/>
              <a:t>10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369065773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S2A. </a:t>
            </a:r>
            <a:r>
              <a:rPr lang="en-US" b="1" dirty="0" err="1"/>
              <a:t>miRTargetLink</a:t>
            </a:r>
            <a:r>
              <a:rPr lang="en-US" b="1" dirty="0"/>
              <a:t> 2.0 Gene Interaction pathway for miR-10a-5p.</a:t>
            </a:r>
            <a:endParaRPr lang="en-PR" b="1" dirty="0"/>
          </a:p>
          <a:p>
            <a:endParaRPr lang="en-P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EAE507-DE51-7F49-9CFE-6816C9B4CD5E}" type="slidenum">
              <a:rPr lang="en-PR" smtClean="0"/>
              <a:t>2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233532389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S2B. </a:t>
            </a:r>
            <a:r>
              <a:rPr lang="en-US" b="1" dirty="0" err="1"/>
              <a:t>miRTargetLink</a:t>
            </a:r>
            <a:r>
              <a:rPr lang="en-US" b="1" dirty="0"/>
              <a:t> 2.0 Gene Interaction pathway for miR-96-5p. </a:t>
            </a:r>
            <a:endParaRPr lang="en-PR" b="1" dirty="0"/>
          </a:p>
          <a:p>
            <a:endParaRPr lang="en-P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EAE507-DE51-7F49-9CFE-6816C9B4CD5E}" type="slidenum">
              <a:rPr lang="en-PR" smtClean="0"/>
              <a:t>3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337891520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S2C. </a:t>
            </a:r>
            <a:r>
              <a:rPr lang="en-US" b="1" dirty="0" err="1"/>
              <a:t>miRTargetLink</a:t>
            </a:r>
            <a:r>
              <a:rPr lang="en-US" b="1" dirty="0"/>
              <a:t> 2.0 Gene Interaction pathway for miR-141-3p. </a:t>
            </a:r>
            <a:endParaRPr lang="en-PR" b="1" dirty="0"/>
          </a:p>
          <a:p>
            <a:endParaRPr lang="en-P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EAE507-DE51-7F49-9CFE-6816C9B4CD5E}" type="slidenum">
              <a:rPr lang="en-PR" smtClean="0"/>
              <a:t>4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389078303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S2D. </a:t>
            </a:r>
            <a:r>
              <a:rPr lang="en-US" b="1" dirty="0" err="1"/>
              <a:t>miRTargetLink</a:t>
            </a:r>
            <a:r>
              <a:rPr lang="en-US" b="1" dirty="0"/>
              <a:t> 2.0 Gene Interaction pathway for miR-182-5p. </a:t>
            </a:r>
            <a:endParaRPr lang="en-PR" b="1" dirty="0"/>
          </a:p>
          <a:p>
            <a:endParaRPr lang="en-P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EAE507-DE51-7F49-9CFE-6816C9B4CD5E}" type="slidenum">
              <a:rPr lang="en-PR" smtClean="0"/>
              <a:t>5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305401079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S2E. </a:t>
            </a:r>
            <a:r>
              <a:rPr lang="en-US" b="1" dirty="0" err="1"/>
              <a:t>miRTargetLink</a:t>
            </a:r>
            <a:r>
              <a:rPr lang="en-US" b="1" dirty="0"/>
              <a:t> 2.0 Gene Interaction pathway for miR-183-5p. </a:t>
            </a:r>
            <a:endParaRPr lang="en-PR" b="1" dirty="0"/>
          </a:p>
          <a:p>
            <a:endParaRPr lang="en-P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EAE507-DE51-7F49-9CFE-6816C9B4CD5E}" type="slidenum">
              <a:rPr lang="en-PR" smtClean="0"/>
              <a:t>6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178777215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S2F. </a:t>
            </a:r>
            <a:r>
              <a:rPr lang="en-US" b="1" dirty="0" err="1"/>
              <a:t>miRTargetLink</a:t>
            </a:r>
            <a:r>
              <a:rPr lang="en-US" b="1" dirty="0"/>
              <a:t> 2.0 Gene Interaction pathway for miR-200c-3p. </a:t>
            </a:r>
            <a:endParaRPr lang="en-PR" b="1" dirty="0"/>
          </a:p>
          <a:p>
            <a:endParaRPr lang="en-P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EAE507-DE51-7F49-9CFE-6816C9B4CD5E}" type="slidenum">
              <a:rPr lang="en-PR" smtClean="0"/>
              <a:t>7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154914660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S2G. </a:t>
            </a:r>
            <a:r>
              <a:rPr lang="en-US" b="1" dirty="0" err="1"/>
              <a:t>miRTargetLink</a:t>
            </a:r>
            <a:r>
              <a:rPr lang="en-US" b="1" dirty="0"/>
              <a:t> 2.0 Gene Interaction pathway for miR-203a-3p. </a:t>
            </a:r>
            <a:endParaRPr lang="en-PR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EAE507-DE51-7F49-9CFE-6816C9B4CD5E}" type="slidenum">
              <a:rPr lang="en-PR" smtClean="0"/>
              <a:t>8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469314124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S2H. </a:t>
            </a:r>
            <a:r>
              <a:rPr lang="en-US" b="1" dirty="0" err="1"/>
              <a:t>miRTargetLink</a:t>
            </a:r>
            <a:r>
              <a:rPr lang="en-US" b="1" dirty="0"/>
              <a:t> 2.0 Gene Interaction pathway for miR-296-5p. </a:t>
            </a:r>
            <a:endParaRPr lang="en-PR" b="1" dirty="0"/>
          </a:p>
          <a:p>
            <a:endParaRPr lang="en-P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2EAE507-DE51-7F49-9CFE-6816C9B4CD5E}" type="slidenum">
              <a:rPr lang="en-PR" smtClean="0"/>
              <a:t>9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27250242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3FA5E6-2966-374B-92E0-309B3F8FFD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PR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12F054D-2001-CF41-80DF-E120F38C01C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P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31B00C-C8F6-7942-9CB5-EDD0F5BBBF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0C700-5A46-1B4B-AC62-9BDD1C5EA94F}" type="datetimeFigureOut">
              <a:rPr lang="en-PR" smtClean="0"/>
              <a:t>03/27/2024</a:t>
            </a:fld>
            <a:endParaRPr lang="en-P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713373-004B-0143-921F-E42DCF07C1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F8C6A7-B79F-D548-B7D3-FC0D84F8C2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3936B-65DF-9E48-AD92-A8DE865D9083}" type="slidenum">
              <a:rPr lang="en-PR" smtClean="0"/>
              <a:t>‹#›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2221938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258F08-9EF4-2C4E-ADEF-C9F8261D10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2316F74-1BD8-884C-9636-A9F310C67C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8439A2-2904-8C4E-8E45-5471605F9A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0C700-5A46-1B4B-AC62-9BDD1C5EA94F}" type="datetimeFigureOut">
              <a:rPr lang="en-PR" smtClean="0"/>
              <a:t>03/27/2024</a:t>
            </a:fld>
            <a:endParaRPr lang="en-P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DEF37F-1730-F340-B5F9-5E885E4913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DA57A7-EDE8-9A4B-800B-18F0DA1348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3936B-65DF-9E48-AD92-A8DE865D9083}" type="slidenum">
              <a:rPr lang="en-PR" smtClean="0"/>
              <a:t>‹#›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36639054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D061FD3-8AD5-4B42-A8B8-56FD35B1098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P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FF99A2-98C0-2846-AEB0-F14121F660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BC9C32-EB37-2342-81DE-A302A8B182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0C700-5A46-1B4B-AC62-9BDD1C5EA94F}" type="datetimeFigureOut">
              <a:rPr lang="en-PR" smtClean="0"/>
              <a:t>03/27/2024</a:t>
            </a:fld>
            <a:endParaRPr lang="en-P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8D488C-FBA3-0E48-A595-A2BC22144B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6F22DA-BC06-4E43-8B57-225D6DDF9F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3936B-65DF-9E48-AD92-A8DE865D9083}" type="slidenum">
              <a:rPr lang="en-PR" smtClean="0"/>
              <a:t>‹#›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4178628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AABC33-E5EC-5740-AF05-818A28DA94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F27557-1A1B-ED46-8B46-8AE98F6A4B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C90D78-17EF-D244-BE78-F2E1ABD25A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0C700-5A46-1B4B-AC62-9BDD1C5EA94F}" type="datetimeFigureOut">
              <a:rPr lang="en-PR" smtClean="0"/>
              <a:t>03/27/2024</a:t>
            </a:fld>
            <a:endParaRPr lang="en-P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6208E9-77E0-774F-BCE0-FF38136A4F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9CFC9B-974A-7F4E-976E-4E75BA6F35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3936B-65DF-9E48-AD92-A8DE865D9083}" type="slidenum">
              <a:rPr lang="en-PR" smtClean="0"/>
              <a:t>‹#›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34661651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DE926B-FA7D-064D-ABA5-AE57B3D324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P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86B5F6-57D1-794C-BA60-93D87477A1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CB264E-0A3A-0543-9170-3A45C899C5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0C700-5A46-1B4B-AC62-9BDD1C5EA94F}" type="datetimeFigureOut">
              <a:rPr lang="en-PR" smtClean="0"/>
              <a:t>03/27/2024</a:t>
            </a:fld>
            <a:endParaRPr lang="en-P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815061-530A-5944-A198-FD4B8F7414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091C10-A53D-E94F-9711-682E95274A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3936B-65DF-9E48-AD92-A8DE865D9083}" type="slidenum">
              <a:rPr lang="en-PR" smtClean="0"/>
              <a:t>‹#›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2212496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0ACCD2-EFE9-2949-B9DD-8DBFD310CF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3C88C2-F7D9-2D4F-82D3-43E16400F3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R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E93107-3A31-2346-B286-4916A8FCA1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R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FBD086-64AD-8F4A-AEC6-F079C453FD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0C700-5A46-1B4B-AC62-9BDD1C5EA94F}" type="datetimeFigureOut">
              <a:rPr lang="en-PR" smtClean="0"/>
              <a:t>03/27/2024</a:t>
            </a:fld>
            <a:endParaRPr lang="en-P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346B3A-1095-E549-B30A-B9662B60FE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F7AAF6-7905-E44B-8412-BFA159B321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3936B-65DF-9E48-AD92-A8DE865D9083}" type="slidenum">
              <a:rPr lang="en-PR" smtClean="0"/>
              <a:t>‹#›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12135331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3DC5E8-F5C6-FA40-8BCF-1E1A7C0080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P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71D076-B738-D043-961D-38F5EF59B9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F3DDC0-E1FA-2545-BAB8-4187125B2D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R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AAB4460-5264-D048-A063-0C57FDD5DC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F9E730B-25A1-DE4C-8B29-34880EE049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R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D4AB082-CB95-8A48-9D91-2E1F5873A9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0C700-5A46-1B4B-AC62-9BDD1C5EA94F}" type="datetimeFigureOut">
              <a:rPr lang="en-PR" smtClean="0"/>
              <a:t>03/27/2024</a:t>
            </a:fld>
            <a:endParaRPr lang="en-PR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9506C6C-6DD6-694D-BC7A-E9FE99C222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R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520D07E-F5E3-C347-89D4-7C5EEA07A3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3936B-65DF-9E48-AD92-A8DE865D9083}" type="slidenum">
              <a:rPr lang="en-PR" smtClean="0"/>
              <a:t>‹#›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3385421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048223-96F0-684F-A36E-04C619BC3C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FC37398-DCF8-F741-9FD5-FBFA33BB39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0C700-5A46-1B4B-AC62-9BDD1C5EA94F}" type="datetimeFigureOut">
              <a:rPr lang="en-PR" smtClean="0"/>
              <a:t>03/27/2024</a:t>
            </a:fld>
            <a:endParaRPr lang="en-PR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CE85B66-9455-C740-8CD0-02E25E854C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R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00D776-1309-EE4B-AA7A-503FA40DBE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3936B-65DF-9E48-AD92-A8DE865D9083}" type="slidenum">
              <a:rPr lang="en-PR" smtClean="0"/>
              <a:t>‹#›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2863770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2F2432E-E092-C34C-ABDD-1ADDBE3D04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0C700-5A46-1B4B-AC62-9BDD1C5EA94F}" type="datetimeFigureOut">
              <a:rPr lang="en-PR" smtClean="0"/>
              <a:t>03/27/2024</a:t>
            </a:fld>
            <a:endParaRPr lang="en-PR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0338847-FF4C-2E49-AEDD-7A499D7C9C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R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9DA6976-FEC1-9849-B2DF-3BBB9B62B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3936B-65DF-9E48-AD92-A8DE865D9083}" type="slidenum">
              <a:rPr lang="en-PR" smtClean="0"/>
              <a:t>‹#›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35033144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9BDC26-E5EA-1F41-AB17-528B801F25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P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382081-7375-704F-882B-C9A5F09FF4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F1BCFDE-ED9B-5C4D-88DD-C9A2BB8DCC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C74347-90ED-6A4A-B2AF-E56FFA9E4A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0C700-5A46-1B4B-AC62-9BDD1C5EA94F}" type="datetimeFigureOut">
              <a:rPr lang="en-PR" smtClean="0"/>
              <a:t>03/27/2024</a:t>
            </a:fld>
            <a:endParaRPr lang="en-P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57EC85-E671-F044-A5EB-B7453B7A58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46D0A4-68DE-6E45-9436-FA0B175541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3936B-65DF-9E48-AD92-A8DE865D9083}" type="slidenum">
              <a:rPr lang="en-PR" smtClean="0"/>
              <a:t>‹#›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6436007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1F8BE9-6BAC-CA48-AD69-4FB5FDB912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PR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8B215EE-64CD-004E-A330-D2240063C3A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P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F9B35B-B6C0-3043-819B-73F0BADC72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F62684-6D6A-3C4B-87F1-0328E947BC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0C700-5A46-1B4B-AC62-9BDD1C5EA94F}" type="datetimeFigureOut">
              <a:rPr lang="en-PR" smtClean="0"/>
              <a:t>03/27/2024</a:t>
            </a:fld>
            <a:endParaRPr lang="en-P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E07A32-0EC4-EE41-8DD0-F973D4029F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E0CD6E-6312-FA4B-8D0D-0B3680B600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3936B-65DF-9E48-AD92-A8DE865D9083}" type="slidenum">
              <a:rPr lang="en-PR" smtClean="0"/>
              <a:t>‹#›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3878827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328484B-D04D-DC41-9E98-2457EC9B13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P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A137BD-BA99-BB43-AAE3-D1D95713D6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ACDA25-F9F1-2E4F-A656-F19540F318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60C700-5A46-1B4B-AC62-9BDD1C5EA94F}" type="datetimeFigureOut">
              <a:rPr lang="en-PR" smtClean="0"/>
              <a:t>03/27/2024</a:t>
            </a:fld>
            <a:endParaRPr lang="en-P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1E4ECC-DA33-2342-BC31-BB24994C0E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P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F6A0A0-7E45-2041-A005-64F05597AAB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F3936B-65DF-9E48-AD92-A8DE865D9083}" type="slidenum">
              <a:rPr lang="en-PR" smtClean="0"/>
              <a:t>‹#›</a:t>
            </a:fld>
            <a:endParaRPr lang="en-PR"/>
          </a:p>
        </p:txBody>
      </p:sp>
    </p:spTree>
    <p:extLst>
      <p:ext uri="{BB962C8B-B14F-4D97-AF65-F5344CB8AC3E}">
        <p14:creationId xmlns:p14="http://schemas.microsoft.com/office/powerpoint/2010/main" val="1812623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P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82D2A10-CB4D-3560-A4E3-38AC930AB4BA}"/>
              </a:ext>
            </a:extLst>
          </p:cNvPr>
          <p:cNvSpPr txBox="1"/>
          <p:nvPr/>
        </p:nvSpPr>
        <p:spPr>
          <a:xfrm>
            <a:off x="317700" y="153275"/>
            <a:ext cx="3209533" cy="393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55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</a:p>
        </p:txBody>
      </p:sp>
      <p:pic>
        <p:nvPicPr>
          <p:cNvPr id="4" name="Picture 3" descr="A network of different colored circles&#10;&#10;Description automatically generated">
            <a:extLst>
              <a:ext uri="{FF2B5EF4-FFF2-40B4-BE49-F238E27FC236}">
                <a16:creationId xmlns:a16="http://schemas.microsoft.com/office/drawing/2014/main" id="{27558017-CF98-EF47-9D60-D8DB8E42CFB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4622" y="523280"/>
            <a:ext cx="8126730" cy="60143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81713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BC189C8-3B68-8F4E-9094-D0F632608D4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76144" y="0"/>
            <a:ext cx="6839712" cy="6858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C773E27-292A-5B44-93B6-4FDF6F8F82F8}"/>
              </a:ext>
            </a:extLst>
          </p:cNvPr>
          <p:cNvSpPr txBox="1"/>
          <p:nvPr/>
        </p:nvSpPr>
        <p:spPr>
          <a:xfrm>
            <a:off x="317700" y="153275"/>
            <a:ext cx="3278462" cy="393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55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I</a:t>
            </a:r>
          </a:p>
        </p:txBody>
      </p:sp>
    </p:spTree>
    <p:extLst>
      <p:ext uri="{BB962C8B-B14F-4D97-AF65-F5344CB8AC3E}">
        <p14:creationId xmlns:p14="http://schemas.microsoft.com/office/powerpoint/2010/main" val="26336485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reeform 1">
            <a:extLst>
              <a:ext uri="{FF2B5EF4-FFF2-40B4-BE49-F238E27FC236}">
                <a16:creationId xmlns:a16="http://schemas.microsoft.com/office/drawing/2014/main" id="{E4036BF6-F0A4-3EAF-9F1B-1304EEA9B602}"/>
              </a:ext>
            </a:extLst>
          </p:cNvPr>
          <p:cNvSpPr/>
          <p:nvPr/>
        </p:nvSpPr>
        <p:spPr>
          <a:xfrm>
            <a:off x="2899682" y="153275"/>
            <a:ext cx="6392636" cy="6662057"/>
          </a:xfrm>
          <a:custGeom>
            <a:avLst/>
            <a:gdLst/>
            <a:ahLst/>
            <a:cxnLst/>
            <a:rect l="l" t="t" r="r" b="b"/>
            <a:pathLst>
              <a:path w="4599931" h="4629608">
                <a:moveTo>
                  <a:pt x="0" y="0"/>
                </a:moveTo>
                <a:lnTo>
                  <a:pt x="4599931" y="0"/>
                </a:lnTo>
                <a:lnTo>
                  <a:pt x="4599931" y="4629608"/>
                </a:lnTo>
                <a:lnTo>
                  <a:pt x="0" y="4629608"/>
                </a:lnTo>
                <a:lnTo>
                  <a:pt x="0" y="0"/>
                </a:lnTo>
                <a:close/>
              </a:path>
            </a:pathLst>
          </a:custGeom>
          <a:blipFill>
            <a:blip r:embed="rId3"/>
            <a:stretch>
              <a:fillRect/>
            </a:stretch>
          </a:blipFill>
        </p:spPr>
        <p:txBody>
          <a:bodyPr/>
          <a:lstStyle/>
          <a:p>
            <a:endParaRPr lang="en-PR" sz="135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759FA4E-0C6E-A29A-95B1-83E72B06F4FC}"/>
              </a:ext>
            </a:extLst>
          </p:cNvPr>
          <p:cNvSpPr txBox="1"/>
          <p:nvPr/>
        </p:nvSpPr>
        <p:spPr>
          <a:xfrm>
            <a:off x="317700" y="153275"/>
            <a:ext cx="3390672" cy="393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55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A</a:t>
            </a:r>
          </a:p>
        </p:txBody>
      </p:sp>
    </p:spTree>
    <p:extLst>
      <p:ext uri="{BB962C8B-B14F-4D97-AF65-F5344CB8AC3E}">
        <p14:creationId xmlns:p14="http://schemas.microsoft.com/office/powerpoint/2010/main" val="4886285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reeform 2">
            <a:extLst>
              <a:ext uri="{FF2B5EF4-FFF2-40B4-BE49-F238E27FC236}">
                <a16:creationId xmlns:a16="http://schemas.microsoft.com/office/drawing/2014/main" id="{F3987D9A-7C72-F0BB-7EED-A5AD3A7CCA41}"/>
              </a:ext>
            </a:extLst>
          </p:cNvPr>
          <p:cNvSpPr/>
          <p:nvPr/>
        </p:nvSpPr>
        <p:spPr>
          <a:xfrm>
            <a:off x="2226128" y="0"/>
            <a:ext cx="7739744" cy="6858000"/>
          </a:xfrm>
          <a:custGeom>
            <a:avLst/>
            <a:gdLst/>
            <a:ahLst/>
            <a:cxnLst/>
            <a:rect l="l" t="t" r="r" b="b"/>
            <a:pathLst>
              <a:path w="4874552" h="4580904">
                <a:moveTo>
                  <a:pt x="0" y="0"/>
                </a:moveTo>
                <a:lnTo>
                  <a:pt x="4874551" y="0"/>
                </a:lnTo>
                <a:lnTo>
                  <a:pt x="4874551" y="4580904"/>
                </a:lnTo>
                <a:lnTo>
                  <a:pt x="0" y="4580904"/>
                </a:lnTo>
                <a:lnTo>
                  <a:pt x="0" y="0"/>
                </a:lnTo>
                <a:close/>
              </a:path>
            </a:pathLst>
          </a:custGeom>
          <a:blipFill>
            <a:blip r:embed="rId3"/>
            <a:stretch>
              <a:fillRect/>
            </a:stretch>
          </a:blipFill>
        </p:spPr>
        <p:txBody>
          <a:bodyPr/>
          <a:lstStyle/>
          <a:p>
            <a:endParaRPr lang="en-PR" sz="135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2CDD351-BE88-5071-F961-5BC233F88EE0}"/>
              </a:ext>
            </a:extLst>
          </p:cNvPr>
          <p:cNvSpPr txBox="1"/>
          <p:nvPr/>
        </p:nvSpPr>
        <p:spPr>
          <a:xfrm>
            <a:off x="317700" y="153275"/>
            <a:ext cx="3390672" cy="393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55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B</a:t>
            </a:r>
          </a:p>
        </p:txBody>
      </p:sp>
    </p:spTree>
    <p:extLst>
      <p:ext uri="{BB962C8B-B14F-4D97-AF65-F5344CB8AC3E}">
        <p14:creationId xmlns:p14="http://schemas.microsoft.com/office/powerpoint/2010/main" val="24913622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FC0A1BE-C86F-3DE9-6502-B1A2B393C60C}"/>
              </a:ext>
            </a:extLst>
          </p:cNvPr>
          <p:cNvSpPr txBox="1"/>
          <p:nvPr/>
        </p:nvSpPr>
        <p:spPr>
          <a:xfrm>
            <a:off x="317700" y="153275"/>
            <a:ext cx="3390672" cy="393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55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C</a:t>
            </a:r>
          </a:p>
        </p:txBody>
      </p:sp>
      <p:pic>
        <p:nvPicPr>
          <p:cNvPr id="5" name="Picture 4" descr="A network of green circles with white text&#10;&#10;Description automatically generated">
            <a:extLst>
              <a:ext uri="{FF2B5EF4-FFF2-40B4-BE49-F238E27FC236}">
                <a16:creationId xmlns:a16="http://schemas.microsoft.com/office/drawing/2014/main" id="{6CB5281C-CD04-A440-95F3-1F0C8ABA82F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5054" y="326169"/>
            <a:ext cx="6927743" cy="63785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58704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reeform 4">
            <a:extLst>
              <a:ext uri="{FF2B5EF4-FFF2-40B4-BE49-F238E27FC236}">
                <a16:creationId xmlns:a16="http://schemas.microsoft.com/office/drawing/2014/main" id="{3284E155-E2EF-CDC3-C159-26344B6ABD39}"/>
              </a:ext>
            </a:extLst>
          </p:cNvPr>
          <p:cNvSpPr/>
          <p:nvPr/>
        </p:nvSpPr>
        <p:spPr>
          <a:xfrm>
            <a:off x="2855495" y="2"/>
            <a:ext cx="7171609" cy="6704724"/>
          </a:xfrm>
          <a:custGeom>
            <a:avLst/>
            <a:gdLst/>
            <a:ahLst/>
            <a:cxnLst/>
            <a:rect l="l" t="t" r="r" b="b"/>
            <a:pathLst>
              <a:path w="4599931" h="4384023">
                <a:moveTo>
                  <a:pt x="0" y="0"/>
                </a:moveTo>
                <a:lnTo>
                  <a:pt x="4599931" y="0"/>
                </a:lnTo>
                <a:lnTo>
                  <a:pt x="4599931" y="4384023"/>
                </a:lnTo>
                <a:lnTo>
                  <a:pt x="0" y="4384023"/>
                </a:lnTo>
                <a:lnTo>
                  <a:pt x="0" y="0"/>
                </a:lnTo>
                <a:close/>
              </a:path>
            </a:pathLst>
          </a:custGeom>
          <a:blipFill>
            <a:blip r:embed="rId3"/>
            <a:stretch>
              <a:fillRect t="-2574" b="-2574"/>
            </a:stretch>
          </a:blipFill>
        </p:spPr>
        <p:txBody>
          <a:bodyPr/>
          <a:lstStyle/>
          <a:p>
            <a:endParaRPr lang="en-PR" sz="135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070F976-686D-02AF-3394-DEFFABD28CAB}"/>
              </a:ext>
            </a:extLst>
          </p:cNvPr>
          <p:cNvSpPr txBox="1"/>
          <p:nvPr/>
        </p:nvSpPr>
        <p:spPr>
          <a:xfrm>
            <a:off x="317700" y="153275"/>
            <a:ext cx="3390672" cy="393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55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D</a:t>
            </a:r>
          </a:p>
        </p:txBody>
      </p:sp>
    </p:spTree>
    <p:extLst>
      <p:ext uri="{BB962C8B-B14F-4D97-AF65-F5344CB8AC3E}">
        <p14:creationId xmlns:p14="http://schemas.microsoft.com/office/powerpoint/2010/main" val="199499357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C773E27-292A-5B44-93B6-4FDF6F8F82F8}"/>
              </a:ext>
            </a:extLst>
          </p:cNvPr>
          <p:cNvSpPr txBox="1"/>
          <p:nvPr/>
        </p:nvSpPr>
        <p:spPr>
          <a:xfrm>
            <a:off x="317700" y="153275"/>
            <a:ext cx="3376245" cy="393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55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E</a:t>
            </a:r>
          </a:p>
        </p:txBody>
      </p:sp>
      <p:pic>
        <p:nvPicPr>
          <p:cNvPr id="4" name="Picture 3" descr="A network of green circles with white text&#10;&#10;Description automatically generated">
            <a:extLst>
              <a:ext uri="{FF2B5EF4-FFF2-40B4-BE49-F238E27FC236}">
                <a16:creationId xmlns:a16="http://schemas.microsoft.com/office/drawing/2014/main" id="{B664EC6F-3E41-9242-8086-CC872382264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3954" y="285329"/>
            <a:ext cx="6381428" cy="6287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23998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reeform 5">
            <a:extLst>
              <a:ext uri="{FF2B5EF4-FFF2-40B4-BE49-F238E27FC236}">
                <a16:creationId xmlns:a16="http://schemas.microsoft.com/office/drawing/2014/main" id="{8200DA6E-DA46-9857-E588-A522D3D04CB6}"/>
              </a:ext>
            </a:extLst>
          </p:cNvPr>
          <p:cNvSpPr/>
          <p:nvPr/>
        </p:nvSpPr>
        <p:spPr>
          <a:xfrm>
            <a:off x="2522764" y="171450"/>
            <a:ext cx="7249886" cy="6686550"/>
          </a:xfrm>
          <a:custGeom>
            <a:avLst/>
            <a:gdLst/>
            <a:ahLst/>
            <a:cxnLst/>
            <a:rect l="l" t="t" r="r" b="b"/>
            <a:pathLst>
              <a:path w="4746011" h="4579656">
                <a:moveTo>
                  <a:pt x="0" y="0"/>
                </a:moveTo>
                <a:lnTo>
                  <a:pt x="4746011" y="0"/>
                </a:lnTo>
                <a:lnTo>
                  <a:pt x="4746011" y="4579655"/>
                </a:lnTo>
                <a:lnTo>
                  <a:pt x="0" y="4579655"/>
                </a:lnTo>
                <a:lnTo>
                  <a:pt x="0" y="0"/>
                </a:lnTo>
                <a:close/>
              </a:path>
            </a:pathLst>
          </a:custGeom>
          <a:blipFill>
            <a:blip r:embed="rId3"/>
            <a:stretch>
              <a:fillRect/>
            </a:stretch>
          </a:blipFill>
        </p:spPr>
        <p:txBody>
          <a:bodyPr/>
          <a:lstStyle/>
          <a:p>
            <a:endParaRPr lang="en-PR" sz="135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02CF9C1-3CB4-82BE-EF18-4928AEB9DA9F}"/>
              </a:ext>
            </a:extLst>
          </p:cNvPr>
          <p:cNvSpPr txBox="1"/>
          <p:nvPr/>
        </p:nvSpPr>
        <p:spPr>
          <a:xfrm>
            <a:off x="317700" y="153275"/>
            <a:ext cx="3363421" cy="393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55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F</a:t>
            </a:r>
          </a:p>
        </p:txBody>
      </p:sp>
    </p:spTree>
    <p:extLst>
      <p:ext uri="{BB962C8B-B14F-4D97-AF65-F5344CB8AC3E}">
        <p14:creationId xmlns:p14="http://schemas.microsoft.com/office/powerpoint/2010/main" val="264495026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reeform 6">
            <a:extLst>
              <a:ext uri="{FF2B5EF4-FFF2-40B4-BE49-F238E27FC236}">
                <a16:creationId xmlns:a16="http://schemas.microsoft.com/office/drawing/2014/main" id="{0C90AAB2-1036-1A8D-6F9A-FDE12773E2A0}"/>
              </a:ext>
            </a:extLst>
          </p:cNvPr>
          <p:cNvSpPr/>
          <p:nvPr/>
        </p:nvSpPr>
        <p:spPr>
          <a:xfrm>
            <a:off x="2691493" y="73479"/>
            <a:ext cx="6809015" cy="6711043"/>
          </a:xfrm>
          <a:custGeom>
            <a:avLst/>
            <a:gdLst/>
            <a:ahLst/>
            <a:cxnLst/>
            <a:rect l="l" t="t" r="r" b="b"/>
            <a:pathLst>
              <a:path w="4226754" h="4328492">
                <a:moveTo>
                  <a:pt x="0" y="0"/>
                </a:moveTo>
                <a:lnTo>
                  <a:pt x="4226754" y="0"/>
                </a:lnTo>
                <a:lnTo>
                  <a:pt x="4226754" y="4328492"/>
                </a:lnTo>
                <a:lnTo>
                  <a:pt x="0" y="4328492"/>
                </a:lnTo>
                <a:lnTo>
                  <a:pt x="0" y="0"/>
                </a:lnTo>
                <a:close/>
              </a:path>
            </a:pathLst>
          </a:custGeom>
          <a:blipFill>
            <a:blip r:embed="rId3"/>
            <a:stretch>
              <a:fillRect/>
            </a:stretch>
          </a:blipFill>
        </p:spPr>
        <p:txBody>
          <a:bodyPr/>
          <a:lstStyle/>
          <a:p>
            <a:endParaRPr lang="en-PR" sz="135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D16754C-2AC3-A936-BB99-AC5E19202505}"/>
              </a:ext>
            </a:extLst>
          </p:cNvPr>
          <p:cNvSpPr txBox="1"/>
          <p:nvPr/>
        </p:nvSpPr>
        <p:spPr>
          <a:xfrm>
            <a:off x="317700" y="153275"/>
            <a:ext cx="3405099" cy="393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55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G</a:t>
            </a:r>
          </a:p>
        </p:txBody>
      </p:sp>
    </p:spTree>
    <p:extLst>
      <p:ext uri="{BB962C8B-B14F-4D97-AF65-F5344CB8AC3E}">
        <p14:creationId xmlns:p14="http://schemas.microsoft.com/office/powerpoint/2010/main" val="138860070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5BA5CEB-2696-7B40-BBC9-212249DDEA26}"/>
              </a:ext>
            </a:extLst>
          </p:cNvPr>
          <p:cNvSpPr txBox="1"/>
          <p:nvPr/>
        </p:nvSpPr>
        <p:spPr>
          <a:xfrm>
            <a:off x="150987" y="153275"/>
            <a:ext cx="3390672" cy="393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955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H</a:t>
            </a:r>
          </a:p>
        </p:txBody>
      </p:sp>
      <p:pic>
        <p:nvPicPr>
          <p:cNvPr id="4" name="Picture 3" descr="A network of green circles with white text&#10;&#10;Description automatically generated">
            <a:extLst>
              <a:ext uri="{FF2B5EF4-FFF2-40B4-BE49-F238E27FC236}">
                <a16:creationId xmlns:a16="http://schemas.microsoft.com/office/drawing/2014/main" id="{C983BADD-8227-F14F-B4F5-9E3A07F7937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1659" y="376532"/>
            <a:ext cx="6114081" cy="61049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201399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9</TotalTime>
  <Words>228</Words>
  <Application>Microsoft Office PowerPoint</Application>
  <PresentationFormat>Widescreen</PresentationFormat>
  <Paragraphs>30</Paragraphs>
  <Slides>10</Slides>
  <Notes>1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LORES COLON MARIENID</dc:creator>
  <cp:lastModifiedBy>MDPI</cp:lastModifiedBy>
  <cp:revision>8</cp:revision>
  <dcterms:created xsi:type="dcterms:W3CDTF">2024-02-20T16:10:49Z</dcterms:created>
  <dcterms:modified xsi:type="dcterms:W3CDTF">2024-03-27T03:05:14Z</dcterms:modified>
</cp:coreProperties>
</file>